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115" autoAdjust="0"/>
    <p:restoredTop sz="94652"/>
  </p:normalViewPr>
  <p:slideViewPr>
    <p:cSldViewPr snapToGrid="0">
      <p:cViewPr varScale="1">
        <p:scale>
          <a:sx n="69" d="100"/>
          <a:sy n="69" d="100"/>
        </p:scale>
        <p:origin x="-816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8AB994-3167-4FD1-AB80-A560FEE480E3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E03DF1-FC7E-405A-BC5B-B54F2CA89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3542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E03DF1-FC7E-405A-BC5B-B54F2CA8964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676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E03DF1-FC7E-405A-BC5B-B54F2CA89643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7315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A784D4E-6EF7-406C-A41D-66DB478830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B259B42-5A9F-4E7A-AC44-6F5365EAC8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574A754-158A-42D3-88D6-4B62803D7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A92F491-689B-46E9-A114-93BDF90A96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0424627-DB26-45C7-9B53-007B4F2D4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394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CFA23D2-82F2-4F52-A2B0-1C72A463F7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486DAD9-6F6A-4A5D-9A64-018FB5B68C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A8871A0-D8FB-46DA-9998-D34B1D3B7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4D33A45-02BF-428F-98E2-651BD591E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4E7F3AB-C1DC-4FB2-945F-C87004F90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713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AA35785B-0449-4B9F-9F62-5862C3C388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A5E914D-24E6-40E1-A191-F109BD81A6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A55B901-6D28-4804-BF02-290B83816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806ED7B-6DE4-4766-8EED-BACF5B0BA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2DCA1A5-5ECA-47A0-97E3-5058E71E4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80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06B7326-D82B-48BE-AD4E-FE98A656C7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EE51036-A9DE-4E7C-88CD-27B98BE66B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9563E04-73BA-433F-A5EA-7454E30DF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3EF8993-11F9-48B1-A799-5BA164C6E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CD8BCE6-E25B-449A-92AF-8E18126D51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637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D67CD6F-012C-49B8-B839-535FDE0C02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58ED186-57DE-4210-A04C-BB03BF43E6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3F648C2-55F8-479E-BDAA-1C969D69A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52D259E-B0D0-4EC3-9F8B-699906433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5DC5F6A-C39C-49AD-A039-1DABEC1F9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744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224B2C8-A6CA-46F2-91AF-04C57CBE22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705E1D2-E48A-43C9-819E-AA029C6967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63517B1-1114-4A44-8725-A959771E45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0BF6C6D-DED6-42FA-9340-ED6F4DFD2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472F9B0-B75E-42AE-ABAC-2D99DF3B0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94D9B01-4EE0-4246-8729-F8A5FF4D6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5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363354A-1D28-4ACA-A8F3-745881A35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1269961-F5A0-46DB-8B16-46F204EB22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37124D6-948B-4082-978D-8E30BF1F06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A4BBE136-B973-40BF-A785-4E7026D6CF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179C3932-4D7A-4955-B6F7-19D7F3DBBB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45DE335-5AA3-4C81-99B2-8714D8687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B08D5395-2F10-4473-90A3-EF753D427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0BDF9F31-672B-4184-BBC8-E643FDEDE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619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159A785-C182-4295-B08C-84478C81C3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4B39215F-6532-4B59-8517-8FECE0916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E43E1DD3-3236-4271-9131-1FBB14F67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19F66919-7396-4A70-A2F3-BC6FB3D3E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973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3B999219-F370-402E-87F9-B61DD433D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7685297-AB50-40BC-8EB9-56D1F6D76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E76BEE42-A6C3-4C3A-9DB2-3BF476C40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990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687D88B-5FBF-4972-B80E-BD8D801788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7B59B84-AFCB-43EE-803F-D0AA71CAF2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20A3A4BC-E088-46D4-B44D-5DCA62E002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959BB1D-9D42-4B09-B51C-6C54ED1F8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5CFB88E-9CA1-4EC5-A470-2A10D4967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E9E6109-41E4-44AF-AB3B-9B7D4D14E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543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E8A95D3-BB08-4E56-A9F6-19BEC3D5F0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8C4C99B5-C87E-4CDD-B93E-E2B753E96D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5503313-3607-4385-B4EA-9477AB2940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C2E05B6-C13A-45AF-B3BD-5F00FF83C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DE8A11B-3CB6-470C-A221-CA96F9013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4BCBD30-59B1-4215-B920-779EF4C44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848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BCB86ECD-80EE-467C-967E-7141BB0A2E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290FB65-6C10-4092-8761-A2261DAAD6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C646338-7E36-4167-A05D-7587B448E2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515F77-BED7-4562-A0B4-996915779BD8}" type="datetimeFigureOut">
              <a:rPr lang="en-US" smtClean="0"/>
              <a:t>3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9FED52E-0D0A-4EC1-8903-5ED583A21B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C08DCD6-EBD5-41D7-A478-F3B88ED088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A457D1-4654-4970-A11B-0FA8EDB25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72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B5264D0A-AF71-41F1-8A01-735A16EA1D4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5468" y="0"/>
            <a:ext cx="9255795" cy="637849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770077" y="6378498"/>
            <a:ext cx="6926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a</a:t>
            </a:r>
            <a:r>
              <a:rPr lang="en-US" dirty="0" smtClean="0"/>
              <a:t>. Annotation of unigenes to </a:t>
            </a:r>
            <a:r>
              <a:rPr lang="en-US" dirty="0" err="1" smtClean="0"/>
              <a:t>phenylpropanoid</a:t>
            </a:r>
            <a:r>
              <a:rPr lang="en-US" dirty="0" smtClean="0"/>
              <a:t>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06472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DF453E22-D74D-4BCB-8D26-EC7706012C2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1840" y="0"/>
            <a:ext cx="9013467" cy="620108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401795" y="6378498"/>
            <a:ext cx="64335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j</a:t>
            </a:r>
            <a:r>
              <a:rPr lang="en-US" dirty="0" smtClean="0"/>
              <a:t>. Annotation of unigenes to </a:t>
            </a:r>
            <a:r>
              <a:rPr lang="en-US" dirty="0" err="1" smtClean="0"/>
              <a:t>diterpenoid</a:t>
            </a:r>
            <a:r>
              <a:rPr lang="en-US" dirty="0" smtClean="0"/>
              <a:t>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131960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E2B41239-174A-40FC-B00B-4B2678F658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9708" y="0"/>
            <a:ext cx="9194019" cy="632259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302388" y="6378498"/>
            <a:ext cx="6808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k</a:t>
            </a:r>
            <a:r>
              <a:rPr lang="en-US" dirty="0" smtClean="0"/>
              <a:t>. Annotation of unigenes to </a:t>
            </a:r>
            <a:r>
              <a:rPr lang="en-US" dirty="0" err="1" smtClean="0"/>
              <a:t>monoterpenoid</a:t>
            </a:r>
            <a:r>
              <a:rPr lang="en-US" dirty="0" smtClean="0"/>
              <a:t>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307171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FE1D927C-B0F7-419E-8529-BBAEF9907B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7136" y="0"/>
            <a:ext cx="9115425" cy="645795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88165" y="6457950"/>
            <a:ext cx="6714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l</a:t>
            </a:r>
            <a:r>
              <a:rPr lang="en-US" dirty="0" smtClean="0"/>
              <a:t>. Annotation of unigenes to </a:t>
            </a:r>
            <a:r>
              <a:rPr lang="en-US" dirty="0" err="1" smtClean="0"/>
              <a:t>brassinosteroid</a:t>
            </a:r>
            <a:r>
              <a:rPr lang="en-US" dirty="0" smtClean="0"/>
              <a:t>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4256480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3BF264F6-F6E5-45BA-ACF9-6E52C2A469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654" y="0"/>
            <a:ext cx="11223770" cy="613861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42448" y="6378498"/>
            <a:ext cx="6520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m</a:t>
            </a:r>
            <a:r>
              <a:rPr lang="en-US" dirty="0" smtClean="0"/>
              <a:t>. Annotation of unigenes to </a:t>
            </a:r>
            <a:r>
              <a:rPr lang="en-US" dirty="0" err="1" smtClean="0"/>
              <a:t>isoflavanoid</a:t>
            </a:r>
            <a:r>
              <a:rPr lang="en-US" dirty="0" smtClean="0"/>
              <a:t>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63815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B3E5DD2D-FE4A-47E4-8835-48BE67090D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86635"/>
            <a:ext cx="12192000" cy="468111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88165" y="6378498"/>
            <a:ext cx="72983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n</a:t>
            </a:r>
            <a:r>
              <a:rPr lang="en-US" dirty="0" smtClean="0"/>
              <a:t>. Annotation of unigenes to polyketide sugar unit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053659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2C24D00C-ED75-4332-8D8E-DA2F069359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5259" y="0"/>
            <a:ext cx="9436097" cy="629604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88165" y="6378498"/>
            <a:ext cx="72352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o</a:t>
            </a:r>
            <a:r>
              <a:rPr lang="en-US" dirty="0" smtClean="0"/>
              <a:t>. Annotation of unigenes to flavone and </a:t>
            </a:r>
            <a:r>
              <a:rPr lang="en-US" dirty="0" err="1" smtClean="0"/>
              <a:t>flavonol</a:t>
            </a:r>
            <a:r>
              <a:rPr lang="en-US" dirty="0" smtClean="0"/>
              <a:t>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250847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84594CC7-6CEF-4F3F-AD96-CA95FF4773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9995" y="0"/>
            <a:ext cx="7920940" cy="644540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88165" y="6378498"/>
            <a:ext cx="6696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p</a:t>
            </a:r>
            <a:r>
              <a:rPr lang="en-US" dirty="0" smtClean="0"/>
              <a:t>. Annotation of unigenes to indole alkaloid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264025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DD4A59CF-C0F8-4FE8-ACC3-67DD6312BA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012" y="110170"/>
            <a:ext cx="10393384" cy="627020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62967" y="6488668"/>
            <a:ext cx="5851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q</a:t>
            </a:r>
            <a:r>
              <a:rPr lang="en-US" dirty="0" smtClean="0"/>
              <a:t>. Annotation of unigenes to lysine degradation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47603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C3A884C3-2B8E-4E79-BA96-5517ADBEBC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3125" y="0"/>
            <a:ext cx="4897122" cy="625583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88165" y="6378498"/>
            <a:ext cx="7227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b</a:t>
            </a:r>
            <a:r>
              <a:rPr lang="en-US" dirty="0" smtClean="0"/>
              <a:t>. Annotation of unigenes to </a:t>
            </a:r>
            <a:r>
              <a:rPr lang="en-US" dirty="0" err="1" smtClean="0"/>
              <a:t>terpenoid</a:t>
            </a:r>
            <a:r>
              <a:rPr lang="en-US" dirty="0" smtClean="0"/>
              <a:t> backbone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83165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A5DFE3DC-4807-4EAE-BC77-7173443EC4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8756" y="0"/>
            <a:ext cx="4938013" cy="636690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88165" y="6378498"/>
            <a:ext cx="5959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c</a:t>
            </a:r>
            <a:r>
              <a:rPr lang="en-US" dirty="0" smtClean="0"/>
              <a:t>. Annotation of unigenes to steroid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57376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43BA2CFA-AB65-4735-B1EF-B448B6169E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1565" y="0"/>
            <a:ext cx="4636311" cy="629617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104742" y="6439795"/>
            <a:ext cx="9209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d</a:t>
            </a:r>
            <a:r>
              <a:rPr lang="en-US" dirty="0" smtClean="0"/>
              <a:t>. Annotation of unigenes to ubiquinone and other </a:t>
            </a:r>
            <a:r>
              <a:rPr lang="en-US" dirty="0" err="1" smtClean="0"/>
              <a:t>terpenoid-quinone</a:t>
            </a:r>
            <a:r>
              <a:rPr lang="en-US" dirty="0" smtClean="0"/>
              <a:t>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91765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679A9BB9-615E-4C2E-AB31-EC25791D694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8957" y="0"/>
            <a:ext cx="4991046" cy="633389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442116" y="6378498"/>
            <a:ext cx="7304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e</a:t>
            </a:r>
            <a:r>
              <a:rPr lang="en-US" dirty="0" smtClean="0"/>
              <a:t>. Annotation of unigenes to </a:t>
            </a:r>
            <a:r>
              <a:rPr lang="en-US" dirty="0" err="1" smtClean="0"/>
              <a:t>isoquinoline</a:t>
            </a:r>
            <a:r>
              <a:rPr lang="en-US" dirty="0" smtClean="0"/>
              <a:t> alkaloid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19813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B5EBCFE1-AC21-4067-9CC1-53C2D53138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6320" y="0"/>
            <a:ext cx="8852703" cy="642720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72964" y="6427207"/>
            <a:ext cx="9099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F </a:t>
            </a:r>
            <a:r>
              <a:rPr lang="en-US" dirty="0" smtClean="0"/>
              <a:t>2f</a:t>
            </a:r>
            <a:r>
              <a:rPr lang="en-US" dirty="0" smtClean="0"/>
              <a:t>. Annotation of unigenes to tropane, </a:t>
            </a:r>
            <a:r>
              <a:rPr lang="en-US" dirty="0" err="1" smtClean="0"/>
              <a:t>piperidine</a:t>
            </a:r>
            <a:r>
              <a:rPr lang="en-US" dirty="0" smtClean="0"/>
              <a:t> and pyridine alkaloid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7196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0F180D69-1818-4818-8BE9-4BC455B68F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5101" y="0"/>
            <a:ext cx="9121799" cy="643816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993164" y="6438167"/>
            <a:ext cx="6205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g</a:t>
            </a:r>
            <a:r>
              <a:rPr lang="en-US" dirty="0" smtClean="0"/>
              <a:t>. Annotation of unigenes to flavonoid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26595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A6B56F06-3C78-42A9-BDA5-4390CC32B2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5970" y="0"/>
            <a:ext cx="8872001" cy="644531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665340" y="6378498"/>
            <a:ext cx="6399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h</a:t>
            </a:r>
            <a:r>
              <a:rPr lang="en-US" dirty="0" smtClean="0"/>
              <a:t>. Annotation of unigenes to carotenoid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10980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264DD8E5-FDF1-4D25-A2AF-11127722628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7480" y="0"/>
            <a:ext cx="5450443" cy="638621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06136" y="6378498"/>
            <a:ext cx="83931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F </a:t>
            </a:r>
            <a:r>
              <a:rPr lang="en-US" dirty="0" smtClean="0"/>
              <a:t>2i</a:t>
            </a:r>
            <a:r>
              <a:rPr lang="en-US" dirty="0" smtClean="0"/>
              <a:t>. Annotation of unigenes to </a:t>
            </a:r>
            <a:r>
              <a:rPr lang="en-US" dirty="0" err="1" smtClean="0"/>
              <a:t>sesquiterpenoid</a:t>
            </a:r>
            <a:r>
              <a:rPr lang="en-US" dirty="0" smtClean="0"/>
              <a:t> and triterpenoid biosynthesis pathw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8322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189</Words>
  <Application>Microsoft Office PowerPoint</Application>
  <PresentationFormat>Custom</PresentationFormat>
  <Paragraphs>19</Paragraphs>
  <Slides>1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1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DU IT</dc:creator>
  <cp:lastModifiedBy>Varun Eranna</cp:lastModifiedBy>
  <cp:revision>7</cp:revision>
  <dcterms:created xsi:type="dcterms:W3CDTF">2022-03-22T05:12:50Z</dcterms:created>
  <dcterms:modified xsi:type="dcterms:W3CDTF">2023-03-15T16:45:15Z</dcterms:modified>
</cp:coreProperties>
</file>